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8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71BA9C5-6AE4-FCBC-BBC0-723EB22DFE5D}" name="平田　理紗" initials="平田　理紗" userId="S::ss4889@cc.saga-u.ac.jp::0859a0fb-d3bc-4737-a683-3c17343421bb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3132" y="54"/>
      </p:cViewPr>
      <p:guideLst>
        <p:guide orient="horz" pos="298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go Masaki" userId="e657396fbe83e9a5" providerId="LiveId" clId="{8321214D-F4A9-48AF-9DB4-5E98EE26A311}"/>
    <pc:docChg chg="modSld">
      <pc:chgData name="Tago Masaki" userId="e657396fbe83e9a5" providerId="LiveId" clId="{8321214D-F4A9-48AF-9DB4-5E98EE26A311}" dt="2022-01-22T01:21:05.833" v="2"/>
      <pc:docMkLst>
        <pc:docMk/>
      </pc:docMkLst>
      <pc:sldChg chg="modSp mod modCm">
        <pc:chgData name="Tago Masaki" userId="e657396fbe83e9a5" providerId="LiveId" clId="{8321214D-F4A9-48AF-9DB4-5E98EE26A311}" dt="2022-01-22T01:21:05.833" v="2"/>
        <pc:sldMkLst>
          <pc:docMk/>
          <pc:sldMk cId="1075599517" sldId="256"/>
        </pc:sldMkLst>
        <pc:spChg chg="mod">
          <ac:chgData name="Tago Masaki" userId="e657396fbe83e9a5" providerId="LiveId" clId="{8321214D-F4A9-48AF-9DB4-5E98EE26A311}" dt="2022-01-22T01:21:01.453" v="1" actId="207"/>
          <ac:spMkLst>
            <pc:docMk/>
            <pc:sldMk cId="1075599517" sldId="256"/>
            <ac:spMk id="79" creationId="{CBAF0ED0-1A2D-426E-BD44-6216B4BCC32C}"/>
          </ac:spMkLst>
        </pc:spChg>
      </pc:sldChg>
    </pc:docChg>
  </pc:docChgLst>
  <pc:docChgLst>
    <pc:chgData name="Tago Masaki" userId="e657396fbe83e9a5" providerId="LiveId" clId="{6F76737C-7C3B-4B74-9B8E-77C6B81DEAF2}"/>
    <pc:docChg chg="">
      <pc:chgData name="Tago Masaki" userId="e657396fbe83e9a5" providerId="LiveId" clId="{6F76737C-7C3B-4B74-9B8E-77C6B81DEAF2}" dt="2022-01-22T09:48:06.103" v="0"/>
      <pc:docMkLst>
        <pc:docMk/>
      </pc:docMkLst>
      <pc:sldChg chg="delCm">
        <pc:chgData name="Tago Masaki" userId="e657396fbe83e9a5" providerId="LiveId" clId="{6F76737C-7C3B-4B74-9B8E-77C6B81DEAF2}" dt="2022-01-22T09:48:06.103" v="0"/>
        <pc:sldMkLst>
          <pc:docMk/>
          <pc:sldMk cId="1075599517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3088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0932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977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2549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6774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6875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1063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80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843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5567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54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7289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tagomas@cc.saga-u.ac.jp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A3856C1-C5E4-416D-B17A-E5A5404E6E02}"/>
              </a:ext>
            </a:extLst>
          </p:cNvPr>
          <p:cNvSpPr txBox="1"/>
          <p:nvPr/>
        </p:nvSpPr>
        <p:spPr>
          <a:xfrm>
            <a:off x="462222" y="1086660"/>
            <a:ext cx="5933555" cy="63146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ternal validation of a</a:t>
            </a:r>
            <a:r>
              <a:rPr lang="en-US" altLang="ja-JP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new predictive model for falls among inpatients using the official Japanese ADL scale,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edriddenness</a:t>
            </a:r>
            <a:r>
              <a:rPr lang="en-US" altLang="ja-JP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ranks: A double-centered prospective cohort study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saki Tago, MD, Ph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; Naoko E.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tsuk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D, Ph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ij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akatani, Ph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,3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Midori Tokushima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Akiko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ogomor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Kazumi Mori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Shun Yamashita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Yoshimasa Oda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Shu-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ch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Yamashita, MD, Ph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General Medicine, Saga University Hospital, Saga, Japan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raduate School of Public Health, Shizuoka Graduate University of Public Health, Shizuoka, Japan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ranslational Research Center for Medical Innovation, Foundation for Biomedical Research and Innovation at Kobe, Hyogo, Japan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General Medicine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ua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Kai Foundation and Oda Hospital, Saga, Japan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rresponding author: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saki Tago, Department of General Medicine, Saga University Hospital, Saga, Japan. Address: 5-1-1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abeshima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aga, 849-8501 Japan. TEL: +81-952-34-3238. FAX: +81-952-34-2029. E-mail: </a:t>
            </a:r>
            <a:r>
              <a:rPr lang="en-US" altLang="ja-JP" sz="1200" u="sng" kern="100" dirty="0">
                <a:solidFill>
                  <a:srgbClr val="0563C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  <a:hlinkClick r:id="rId2"/>
              </a:rPr>
              <a:t>tagomas@cc.saga-u.ac.jp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89534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1780E909-22C3-4E26-886C-90C92950440F}"/>
              </a:ext>
            </a:extLst>
          </p:cNvPr>
          <p:cNvCxnSpPr>
            <a:cxnSpLocks/>
          </p:cNvCxnSpPr>
          <p:nvPr/>
        </p:nvCxnSpPr>
        <p:spPr>
          <a:xfrm>
            <a:off x="-704386" y="779639"/>
            <a:ext cx="0" cy="8925615"/>
          </a:xfrm>
          <a:prstGeom prst="line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図 1">
            <a:extLst>
              <a:ext uri="{FF2B5EF4-FFF2-40B4-BE49-F238E27FC236}">
                <a16:creationId xmlns:a16="http://schemas.microsoft.com/office/drawing/2014/main" id="{7B1515C2-1943-4DB3-9AA9-5648FA7D27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5122" y="878806"/>
            <a:ext cx="6047756" cy="8455885"/>
          </a:xfrm>
          <a:prstGeom prst="rect">
            <a:avLst/>
          </a:prstGeom>
        </p:spPr>
      </p:pic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CBAF0ED0-1A2D-426E-BD44-6216B4BCC32C}"/>
              </a:ext>
            </a:extLst>
          </p:cNvPr>
          <p:cNvSpPr txBox="1"/>
          <p:nvPr/>
        </p:nvSpPr>
        <p:spPr>
          <a:xfrm>
            <a:off x="290513" y="166518"/>
            <a:ext cx="3781424" cy="4047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</a:t>
            </a:r>
            <a:r>
              <a:rPr lang="en-US" altLang="ja-JP" sz="12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9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Figure.</a:t>
            </a:r>
            <a:r>
              <a:rPr lang="ja-JP" altLang="en-US" sz="12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he results of subgroup analysis</a:t>
            </a:r>
            <a:endParaRPr lang="ja-JP" altLang="ja-JP" sz="1050" b="1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5599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201</Words>
  <Application>Microsoft Office PowerPoint</Application>
  <PresentationFormat>A4 210 x 297 mm</PresentationFormat>
  <Paragraphs>1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go Masaki</dc:creator>
  <cp:lastModifiedBy>Tago Masaki</cp:lastModifiedBy>
  <cp:revision>7</cp:revision>
  <dcterms:created xsi:type="dcterms:W3CDTF">2021-04-07T23:19:43Z</dcterms:created>
  <dcterms:modified xsi:type="dcterms:W3CDTF">2022-01-22T09:48:07Z</dcterms:modified>
</cp:coreProperties>
</file>